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8" r:id="rId2"/>
    <p:sldId id="263" r:id="rId3"/>
    <p:sldId id="277" r:id="rId4"/>
    <p:sldId id="278" r:id="rId5"/>
    <p:sldId id="279" r:id="rId6"/>
    <p:sldId id="280" r:id="rId7"/>
    <p:sldId id="281" r:id="rId8"/>
    <p:sldId id="282" r:id="rId9"/>
    <p:sldId id="284" r:id="rId10"/>
    <p:sldId id="285" r:id="rId11"/>
    <p:sldId id="286" r:id="rId12"/>
    <p:sldId id="287" r:id="rId13"/>
  </p:sldIdLst>
  <p:sldSz cx="12192000" cy="16200438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81" autoAdjust="0"/>
    <p:restoredTop sz="94660"/>
  </p:normalViewPr>
  <p:slideViewPr>
    <p:cSldViewPr snapToGrid="0">
      <p:cViewPr varScale="1">
        <p:scale>
          <a:sx n="47" d="100"/>
          <a:sy n="47" d="100"/>
        </p:scale>
        <p:origin x="304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789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1323"/>
            <a:ext cx="10363200" cy="564015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08981"/>
            <a:ext cx="9144000" cy="391135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52159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26109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2524"/>
            <a:ext cx="2628900" cy="13729122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2524"/>
            <a:ext cx="7734300" cy="13729122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37571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2855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38864"/>
            <a:ext cx="10515600" cy="673893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41548"/>
            <a:ext cx="10515600" cy="354384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8209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2617"/>
            <a:ext cx="5181600" cy="1027902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2617"/>
            <a:ext cx="5181600" cy="1027902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04857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2527"/>
            <a:ext cx="10515600" cy="3131336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1359"/>
            <a:ext cx="5157787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17660"/>
            <a:ext cx="5157787" cy="8703987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1359"/>
            <a:ext cx="5183188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17660"/>
            <a:ext cx="5183188" cy="8703987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00424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58235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87888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2567"/>
            <a:ext cx="6172200" cy="1151281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49590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2567"/>
            <a:ext cx="6172200" cy="1151281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4222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2527"/>
            <a:ext cx="10515600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2617"/>
            <a:ext cx="10515600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C7C3C-12E8-4F8E-8DBD-CCE08EABAC40}" type="datetimeFigureOut">
              <a:rPr lang="ru-RU" smtClean="0"/>
              <a:t>24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15410"/>
            <a:ext cx="41148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6FA24-4B88-48B2-A98D-D3C283C186F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9460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/>
          <p:cNvPicPr>
            <a:picLocks noChangeAspect="1"/>
          </p:cNvPicPr>
          <p:nvPr/>
        </p:nvPicPr>
        <p:blipFill rotWithShape="1">
          <a:blip r:embed="rId2"/>
          <a:srcRect t="-110" r="26980" b="51372"/>
          <a:stretch/>
        </p:blipFill>
        <p:spPr>
          <a:xfrm>
            <a:off x="4262669" y="1402081"/>
            <a:ext cx="7162019" cy="82063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678899" y="463339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6" name="Прямоугольник 5"/>
          <p:cNvSpPr/>
          <p:nvPr/>
        </p:nvSpPr>
        <p:spPr>
          <a:xfrm>
            <a:off x="665364" y="2475145"/>
            <a:ext cx="10764000" cy="61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7" name="Прямоугольник 6"/>
          <p:cNvSpPr/>
          <p:nvPr/>
        </p:nvSpPr>
        <p:spPr>
          <a:xfrm>
            <a:off x="665364" y="3944421"/>
            <a:ext cx="10764000" cy="4306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8" name="Прямоугольник 7"/>
          <p:cNvSpPr/>
          <p:nvPr/>
        </p:nvSpPr>
        <p:spPr>
          <a:xfrm>
            <a:off x="665364" y="4370457"/>
            <a:ext cx="10764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9" name="Прямоугольник 8"/>
          <p:cNvSpPr/>
          <p:nvPr/>
        </p:nvSpPr>
        <p:spPr>
          <a:xfrm>
            <a:off x="665364" y="3081950"/>
            <a:ext cx="10764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0" name="TextBox 9"/>
          <p:cNvSpPr txBox="1"/>
          <p:nvPr/>
        </p:nvSpPr>
        <p:spPr>
          <a:xfrm>
            <a:off x="678899" y="2520720"/>
            <a:ext cx="35371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400" b="1" dirty="0" smtClean="0"/>
              <a:t>1. </a:t>
            </a:r>
            <a:r>
              <a:rPr lang="en-US" sz="1400" b="1" dirty="0" smtClean="0"/>
              <a:t>Check </a:t>
            </a:r>
            <a:r>
              <a:rPr lang="en-US" sz="1400" b="1" dirty="0"/>
              <a:t>the 5`-end of mRNA using FANTOM5 CAGE </a:t>
            </a:r>
            <a:r>
              <a:rPr lang="en-US" sz="1400" b="1" dirty="0" smtClean="0"/>
              <a:t>data</a:t>
            </a:r>
            <a:endParaRPr lang="ru-RU" sz="1400" b="1" dirty="0"/>
          </a:p>
        </p:txBody>
      </p:sp>
      <p:sp>
        <p:nvSpPr>
          <p:cNvPr id="11" name="Прямоугольник 10"/>
          <p:cNvSpPr/>
          <p:nvPr/>
        </p:nvSpPr>
        <p:spPr>
          <a:xfrm>
            <a:off x="665364" y="5230033"/>
            <a:ext cx="10764000" cy="104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2" name="Прямоугольник 11"/>
          <p:cNvSpPr/>
          <p:nvPr/>
        </p:nvSpPr>
        <p:spPr>
          <a:xfrm>
            <a:off x="664703" y="6274477"/>
            <a:ext cx="10764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3" name="Прямоугольник 12"/>
          <p:cNvSpPr/>
          <p:nvPr/>
        </p:nvSpPr>
        <p:spPr>
          <a:xfrm>
            <a:off x="6515100" y="3294318"/>
            <a:ext cx="4251960" cy="648000"/>
          </a:xfrm>
          <a:prstGeom prst="rect">
            <a:avLst/>
          </a:prstGeom>
          <a:solidFill>
            <a:srgbClr val="FFFF00">
              <a:alpha val="16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Прямоугольник 13"/>
          <p:cNvSpPr/>
          <p:nvPr/>
        </p:nvSpPr>
        <p:spPr>
          <a:xfrm>
            <a:off x="666582" y="7138365"/>
            <a:ext cx="10764000" cy="43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5" name="Прямоугольник 14"/>
          <p:cNvSpPr/>
          <p:nvPr/>
        </p:nvSpPr>
        <p:spPr>
          <a:xfrm>
            <a:off x="665058" y="7574168"/>
            <a:ext cx="10764000" cy="41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6" name="Прямоугольник 15"/>
          <p:cNvSpPr/>
          <p:nvPr/>
        </p:nvSpPr>
        <p:spPr>
          <a:xfrm>
            <a:off x="665364" y="7984048"/>
            <a:ext cx="10764000" cy="122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7" name="Прямоугольник 16"/>
          <p:cNvSpPr/>
          <p:nvPr/>
        </p:nvSpPr>
        <p:spPr>
          <a:xfrm>
            <a:off x="666686" y="9205038"/>
            <a:ext cx="10764000" cy="4068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cxnSp>
        <p:nvCxnSpPr>
          <p:cNvPr id="18" name="Прямая со стрелкой 17"/>
          <p:cNvCxnSpPr/>
          <p:nvPr/>
        </p:nvCxnSpPr>
        <p:spPr>
          <a:xfrm>
            <a:off x="7568794" y="2758563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Прямая со стрелкой 18"/>
          <p:cNvCxnSpPr/>
          <p:nvPr/>
        </p:nvCxnSpPr>
        <p:spPr>
          <a:xfrm>
            <a:off x="7730339" y="4785516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Прямая со стрелкой 19"/>
          <p:cNvCxnSpPr/>
          <p:nvPr/>
        </p:nvCxnSpPr>
        <p:spPr>
          <a:xfrm>
            <a:off x="7754289" y="5704056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Прямая со стрелкой 20"/>
          <p:cNvCxnSpPr/>
          <p:nvPr/>
        </p:nvCxnSpPr>
        <p:spPr>
          <a:xfrm>
            <a:off x="7604784" y="7382139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Прямая со стрелкой 21"/>
          <p:cNvCxnSpPr/>
          <p:nvPr/>
        </p:nvCxnSpPr>
        <p:spPr>
          <a:xfrm>
            <a:off x="7730340" y="7798149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Прямоугольник 22"/>
          <p:cNvSpPr/>
          <p:nvPr/>
        </p:nvSpPr>
        <p:spPr>
          <a:xfrm>
            <a:off x="8003462" y="6462684"/>
            <a:ext cx="886464" cy="673498"/>
          </a:xfrm>
          <a:prstGeom prst="rect">
            <a:avLst/>
          </a:prstGeom>
          <a:solidFill>
            <a:srgbClr val="FFFF00">
              <a:alpha val="16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pic>
        <p:nvPicPr>
          <p:cNvPr id="24" name="Рисунок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1717" y="10525315"/>
            <a:ext cx="7160400" cy="365827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5" name="Прямая со стрелкой 24"/>
          <p:cNvCxnSpPr/>
          <p:nvPr/>
        </p:nvCxnSpPr>
        <p:spPr>
          <a:xfrm>
            <a:off x="7058537" y="10954851"/>
            <a:ext cx="546247" cy="90839"/>
          </a:xfrm>
          <a:prstGeom prst="straightConnector1">
            <a:avLst/>
          </a:prstGeom>
          <a:ln w="34925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664703" y="9952514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794862" y="1848615"/>
            <a:ext cx="1331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omments</a:t>
            </a:r>
            <a:endParaRPr lang="ru-RU" sz="2000" b="1" dirty="0"/>
          </a:p>
        </p:txBody>
      </p:sp>
      <p:sp>
        <p:nvSpPr>
          <p:cNvPr id="28" name="Прямоугольник 27"/>
          <p:cNvSpPr/>
          <p:nvPr/>
        </p:nvSpPr>
        <p:spPr>
          <a:xfrm>
            <a:off x="664703" y="10519340"/>
            <a:ext cx="10764000" cy="366424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9" name="TextBox 28"/>
          <p:cNvSpPr txBox="1"/>
          <p:nvPr/>
        </p:nvSpPr>
        <p:spPr>
          <a:xfrm>
            <a:off x="678900" y="3328129"/>
            <a:ext cx="357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</a:t>
            </a:r>
            <a:r>
              <a:rPr lang="ru-RU" sz="1400" b="1" dirty="0"/>
              <a:t>. </a:t>
            </a:r>
            <a:r>
              <a:rPr lang="en-US" sz="1400" b="1" dirty="0"/>
              <a:t>Check </a:t>
            </a:r>
            <a:r>
              <a:rPr lang="en-US" sz="1400" b="1" dirty="0" smtClean="0"/>
              <a:t>RNA-</a:t>
            </a:r>
            <a:r>
              <a:rPr lang="en-US" sz="1400" b="1" dirty="0" err="1" smtClean="0"/>
              <a:t>seq</a:t>
            </a:r>
            <a:r>
              <a:rPr lang="en-US" sz="1400" b="1" dirty="0" smtClean="0"/>
              <a:t> </a:t>
            </a:r>
            <a:r>
              <a:rPr lang="en-US" sz="1400" b="1" dirty="0"/>
              <a:t>coverage data</a:t>
            </a:r>
            <a:endParaRPr lang="ru-RU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678900" y="3898133"/>
            <a:ext cx="35371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</a:t>
            </a:r>
            <a:r>
              <a:rPr lang="ru-RU" sz="1400" b="1" dirty="0"/>
              <a:t>. </a:t>
            </a:r>
            <a:r>
              <a:rPr lang="en-US" sz="1400" b="1" dirty="0"/>
              <a:t>Matching the gene structure with CAGE and </a:t>
            </a:r>
            <a:r>
              <a:rPr lang="en-US" sz="1400" b="1" dirty="0" err="1"/>
              <a:t>RNAseq</a:t>
            </a:r>
            <a:r>
              <a:rPr lang="en-US" sz="1400" b="1" dirty="0"/>
              <a:t> data</a:t>
            </a:r>
            <a:endParaRPr lang="ru-RU" sz="14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664702" y="4523906"/>
            <a:ext cx="35919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400" b="1" dirty="0"/>
              <a:t>4. </a:t>
            </a:r>
            <a:r>
              <a:rPr lang="en-US" sz="1400" b="1" dirty="0" smtClean="0"/>
              <a:t>Searching for distinct </a:t>
            </a:r>
            <a:r>
              <a:rPr lang="en-US" sz="1400" b="1" dirty="0"/>
              <a:t>peak of initiating ribosome profiling </a:t>
            </a:r>
            <a:r>
              <a:rPr lang="en-US" sz="1400" b="1" dirty="0" smtClean="0"/>
              <a:t>data</a:t>
            </a:r>
            <a:endParaRPr lang="ru-RU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658285" y="5391401"/>
            <a:ext cx="34169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</a:t>
            </a:r>
            <a:r>
              <a:rPr lang="ru-RU" sz="1400" b="1" dirty="0" smtClean="0"/>
              <a:t>. </a:t>
            </a:r>
            <a:r>
              <a:rPr lang="en-US" sz="1400" b="1" dirty="0" smtClean="0"/>
              <a:t>Check that peak corresponded </a:t>
            </a:r>
            <a:r>
              <a:rPr lang="en-US" sz="1400" b="1" dirty="0"/>
              <a:t>to distinct elongating ribosomes profiling signal</a:t>
            </a:r>
            <a:endParaRPr lang="ru-RU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664702" y="7083557"/>
            <a:ext cx="35919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7</a:t>
            </a:r>
            <a:r>
              <a:rPr lang="ru-RU" sz="1400" b="1" dirty="0" smtClean="0"/>
              <a:t>. </a:t>
            </a:r>
            <a:r>
              <a:rPr lang="en-US" sz="1400" b="1" dirty="0"/>
              <a:t>Check that </a:t>
            </a:r>
            <a:r>
              <a:rPr lang="en-US" sz="1400" b="1" dirty="0" smtClean="0"/>
              <a:t>peak </a:t>
            </a:r>
            <a:r>
              <a:rPr lang="en-US" sz="1400" b="1" dirty="0"/>
              <a:t>matched with Kozak consensus</a:t>
            </a:r>
            <a:endParaRPr lang="ru-RU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664702" y="7616903"/>
            <a:ext cx="3511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8</a:t>
            </a:r>
            <a:r>
              <a:rPr lang="ru-RU" sz="1400" b="1" dirty="0" smtClean="0"/>
              <a:t>. </a:t>
            </a:r>
            <a:r>
              <a:rPr lang="en-US" sz="1400" b="1" dirty="0" smtClean="0"/>
              <a:t>Check the translation of mouse uORF</a:t>
            </a:r>
            <a:endParaRPr lang="ru-RU" sz="14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668768" y="8244213"/>
            <a:ext cx="35069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mparison with previously published </a:t>
            </a:r>
            <a:r>
              <a:rPr lang="en-US" sz="1400" b="1" dirty="0" err="1" smtClean="0"/>
              <a:t>uTISs</a:t>
            </a:r>
            <a:r>
              <a:rPr lang="en-US" sz="1400" b="1" dirty="0" smtClean="0"/>
              <a:t> data</a:t>
            </a:r>
            <a:endParaRPr lang="ru-RU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658286" y="9226183"/>
            <a:ext cx="3511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400" b="1" dirty="0" smtClean="0"/>
              <a:t>9. </a:t>
            </a:r>
            <a:r>
              <a:rPr lang="en-US" sz="1400" b="1" dirty="0" smtClean="0"/>
              <a:t>Creating a file with our predicted uORFs</a:t>
            </a:r>
            <a:endParaRPr lang="ru-RU" sz="14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676683" y="11805562"/>
            <a:ext cx="351105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0</a:t>
            </a:r>
            <a:r>
              <a:rPr lang="ru-RU" sz="1400" b="1" dirty="0"/>
              <a:t>. </a:t>
            </a:r>
            <a:r>
              <a:rPr lang="en-US" sz="1400" b="1" dirty="0"/>
              <a:t>Check that Trips-</a:t>
            </a:r>
            <a:r>
              <a:rPr lang="en-US" sz="1400" b="1" dirty="0" err="1"/>
              <a:t>Viz</a:t>
            </a:r>
            <a:r>
              <a:rPr lang="en-US" sz="1400" b="1" dirty="0"/>
              <a:t> single transcript plot (showing the ORF architecture) confirmed the translation of expected </a:t>
            </a:r>
            <a:r>
              <a:rPr lang="en-US" sz="1400" b="1" dirty="0" smtClean="0"/>
              <a:t>ORF</a:t>
            </a:r>
            <a:endParaRPr lang="ru-RU" sz="1400" b="1" dirty="0"/>
          </a:p>
        </p:txBody>
      </p:sp>
      <p:sp>
        <p:nvSpPr>
          <p:cNvPr id="41" name="Прямоугольник 40"/>
          <p:cNvSpPr/>
          <p:nvPr/>
        </p:nvSpPr>
        <p:spPr>
          <a:xfrm>
            <a:off x="678899" y="14482124"/>
            <a:ext cx="107498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lgorithm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manua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of alternative translation initiation sites (TISs)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 5’UTRs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sing publicly available data presented in th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WIPS-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z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rips-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z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browsers, Kozak score predictions and mouse uORFs data from Wang et al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460660" y="990502"/>
            <a:ext cx="28344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Tracks in GWIPS-browser</a:t>
            </a:r>
            <a:endParaRPr lang="ru-RU" sz="20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658285" y="6392586"/>
            <a:ext cx="34169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</a:t>
            </a:r>
            <a:r>
              <a:rPr lang="ru-RU" sz="1400" b="1" dirty="0" smtClean="0"/>
              <a:t>. </a:t>
            </a:r>
            <a:r>
              <a:rPr lang="en-US" sz="1400" b="1" dirty="0" smtClean="0"/>
              <a:t>Check that peak corresponded </a:t>
            </a:r>
            <a:r>
              <a:rPr lang="en-US" sz="1400" b="1" dirty="0"/>
              <a:t>to </a:t>
            </a:r>
            <a:r>
              <a:rPr lang="en-US" sz="1400" b="1" dirty="0" err="1" smtClean="0"/>
              <a:t>Ribo-seq</a:t>
            </a:r>
            <a:r>
              <a:rPr lang="en-US" sz="1400" b="1" dirty="0" smtClean="0"/>
              <a:t> coverage data</a:t>
            </a:r>
            <a:endParaRPr lang="ru-RU" sz="1400" b="1" dirty="0"/>
          </a:p>
        </p:txBody>
      </p:sp>
      <p:sp>
        <p:nvSpPr>
          <p:cNvPr id="40" name="Прямоугольник 39"/>
          <p:cNvSpPr/>
          <p:nvPr/>
        </p:nvSpPr>
        <p:spPr>
          <a:xfrm>
            <a:off x="7568794" y="10501371"/>
            <a:ext cx="434668" cy="3414386"/>
          </a:xfrm>
          <a:prstGeom prst="rect">
            <a:avLst/>
          </a:prstGeom>
          <a:solidFill>
            <a:srgbClr val="FFFF00">
              <a:alpha val="16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300171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https://gwips.ucc.ie/trash/hgt/hgt_gwips_42ed_fb592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243"/>
          <a:stretch/>
        </p:blipFill>
        <p:spPr bwMode="auto">
          <a:xfrm>
            <a:off x="1150630" y="1031574"/>
            <a:ext cx="10406310" cy="7029596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Рисунок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1" y="9473980"/>
            <a:ext cx="10401289" cy="528748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>
            <a:endCxn id="27" idx="0"/>
          </p:cNvCxnSpPr>
          <p:nvPr/>
        </p:nvCxnSpPr>
        <p:spPr>
          <a:xfrm flipH="1">
            <a:off x="4581751" y="8067746"/>
            <a:ext cx="1575603" cy="1399658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5943994" y="8067746"/>
            <a:ext cx="1224294" cy="1414164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4574472" y="9466670"/>
            <a:ext cx="1369522" cy="4907698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261791" y="9467404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6160288" y="1031844"/>
            <a:ext cx="1008000" cy="7029326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6157354" y="1268476"/>
            <a:ext cx="1010934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5975874" y="9469968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4973856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2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I2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953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https://gwips.ucc.ie/trash/hgt/hgt_gwips_4448_fb67c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4972"/>
          <a:stretch/>
        </p:blipFill>
        <p:spPr bwMode="auto">
          <a:xfrm>
            <a:off x="1150628" y="1005898"/>
            <a:ext cx="10401291" cy="7725422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Рисунок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0" y="9467633"/>
            <a:ext cx="10401290" cy="527452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>
            <a:off x="4428614" y="8731320"/>
            <a:ext cx="962722" cy="736313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>
            <a:off x="5382614" y="8731320"/>
            <a:ext cx="993802" cy="729254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5391336" y="9460574"/>
            <a:ext cx="985080" cy="488941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5096578" y="11033437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4428614" y="990242"/>
            <a:ext cx="954000" cy="7741078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4420548" y="1403658"/>
            <a:ext cx="962066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7938786" y="9469968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28" y="15066437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3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TN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863933" y="9479596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065178" y="11033437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</p:spTree>
    <p:extLst>
      <p:ext uri="{BB962C8B-B14F-4D97-AF65-F5344CB8AC3E}">
        <p14:creationId xmlns:p14="http://schemas.microsoft.com/office/powerpoint/2010/main" val="36470638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https://gwips.ucc.ie/trash/hgt/hgt_gwips_47c4_fb7cc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874"/>
          <a:stretch/>
        </p:blipFill>
        <p:spPr bwMode="auto">
          <a:xfrm>
            <a:off x="1150630" y="1035798"/>
            <a:ext cx="10404000" cy="7394844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Рисунок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0" y="9470382"/>
            <a:ext cx="10402727" cy="534289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>
            <a:endCxn id="27" idx="0"/>
          </p:cNvCxnSpPr>
          <p:nvPr/>
        </p:nvCxnSpPr>
        <p:spPr>
          <a:xfrm flipH="1">
            <a:off x="6075013" y="8430642"/>
            <a:ext cx="2639245" cy="1045297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6505956" y="8430641"/>
            <a:ext cx="2649108" cy="1045298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6108192" y="9466670"/>
            <a:ext cx="390144" cy="4932082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5755053" y="9475939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8716798" y="1025639"/>
            <a:ext cx="450000" cy="7405004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8714258" y="1433975"/>
            <a:ext cx="440806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7071918" y="9466670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5065448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4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FDH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322573" y="12096111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636934" y="12206955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744125" y="12407010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</p:spTree>
    <p:extLst>
      <p:ext uri="{BB962C8B-B14F-4D97-AF65-F5344CB8AC3E}">
        <p14:creationId xmlns:p14="http://schemas.microsoft.com/office/powerpoint/2010/main" val="2657943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 descr="https://gwips.ucc.ie/trash/hgt/hgt_gwips_13f3_f9c83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0495"/>
          <a:stretch/>
        </p:blipFill>
        <p:spPr bwMode="auto">
          <a:xfrm>
            <a:off x="1150630" y="1001364"/>
            <a:ext cx="10401290" cy="687172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Рисунок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0" y="9207590"/>
            <a:ext cx="10401290" cy="541666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3184588" y="7893682"/>
            <a:ext cx="5546616" cy="1313908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9124586" y="7877627"/>
            <a:ext cx="2033952" cy="1329963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3184584" y="9192350"/>
            <a:ext cx="5940000" cy="507600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68437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926767" y="9205276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8678698" y="1001364"/>
            <a:ext cx="2484000" cy="687600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8678698" y="1569720"/>
            <a:ext cx="2484000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8097282" y="9195648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4881258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AX9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88276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https://gwips.ucc.ie/trash/hgt/hgt_gwips_1ec7_fa32b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924"/>
          <a:stretch/>
        </p:blipFill>
        <p:spPr bwMode="auto">
          <a:xfrm>
            <a:off x="1150631" y="1005898"/>
            <a:ext cx="10401290" cy="7028591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Рисунок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0" y="9466670"/>
            <a:ext cx="10401290" cy="531033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3273971" y="8049729"/>
            <a:ext cx="4247357" cy="1424787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4589506" y="8057123"/>
            <a:ext cx="3930524" cy="1394307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3349601" y="9459276"/>
            <a:ext cx="1232559" cy="489600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926767" y="9479596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7521328" y="1011921"/>
            <a:ext cx="998702" cy="7037808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7514585" y="1569537"/>
            <a:ext cx="1005446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4167913" y="9446350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5100320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AST1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316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 descr="https://gwips.ucc.ie/trash/hgt/hgt_gwips_34bd_fae39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211"/>
          <a:stretch/>
        </p:blipFill>
        <p:spPr bwMode="auto">
          <a:xfrm>
            <a:off x="1150631" y="998782"/>
            <a:ext cx="10401290" cy="7034628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Рисунок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4932" y="9474611"/>
            <a:ext cx="10396988" cy="536681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3184589" y="8041351"/>
            <a:ext cx="1499912" cy="1440559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4831082" y="8033410"/>
            <a:ext cx="1451514" cy="1441201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2940744" y="9466670"/>
            <a:ext cx="1890336" cy="496800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620784" y="9489851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4672926" y="998783"/>
            <a:ext cx="1623701" cy="7034628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4684501" y="1228048"/>
            <a:ext cx="1598095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6616892" y="9466670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43873" y="15172680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6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TT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9387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https://gwips.ucc.ie/trash/hgt/hgt_gwips_2f8a_fad80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791"/>
          <a:stretch/>
        </p:blipFill>
        <p:spPr bwMode="auto">
          <a:xfrm>
            <a:off x="1171386" y="1036379"/>
            <a:ext cx="10398185" cy="7022240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Рисунок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8280" y="9473110"/>
            <a:ext cx="10401291" cy="526525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>
            <a:off x="4113556" y="8158859"/>
            <a:ext cx="724568" cy="1311109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>
            <a:off x="4659754" y="8121993"/>
            <a:ext cx="711784" cy="1357603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4838124" y="9469968"/>
            <a:ext cx="540000" cy="4924212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339795" y="9479611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4113556" y="1036378"/>
            <a:ext cx="504000" cy="709200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4122052" y="1418552"/>
            <a:ext cx="487286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7784765" y="9473110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5068114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L2A1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176128" y="10824328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</p:spTree>
    <p:extLst>
      <p:ext uri="{BB962C8B-B14F-4D97-AF65-F5344CB8AC3E}">
        <p14:creationId xmlns:p14="http://schemas.microsoft.com/office/powerpoint/2010/main" val="2175274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4" name="Picture 4" descr="https://gwips.ucc.ie/trash/hgt/hgt_gwips_390b_fb018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392"/>
          <a:stretch/>
        </p:blipFill>
        <p:spPr bwMode="auto">
          <a:xfrm>
            <a:off x="1077419" y="1005899"/>
            <a:ext cx="10406285" cy="7463095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Рисунок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7419" y="9464356"/>
            <a:ext cx="10406285" cy="535217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4546025" y="8468994"/>
            <a:ext cx="1459183" cy="995362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5029200" y="8476069"/>
            <a:ext cx="1443990" cy="1005841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4546024" y="9466670"/>
            <a:ext cx="483176" cy="494021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943885" y="9464356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6018302" y="998824"/>
            <a:ext cx="468000" cy="7470170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6005208" y="1390015"/>
            <a:ext cx="467982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8097282" y="9469968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077419" y="15137530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8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AT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681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https://gwips.ucc.ie/trash/hgt/hgt_gwips_3c54_fb1a5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1682"/>
          <a:stretch/>
        </p:blipFill>
        <p:spPr bwMode="auto">
          <a:xfrm>
            <a:off x="1150630" y="1005898"/>
            <a:ext cx="10401290" cy="729809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Рисунок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30" y="9479596"/>
            <a:ext cx="10401290" cy="536987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3184588" y="8303997"/>
            <a:ext cx="1643469" cy="1177913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>
            <a:off x="9077036" y="8313625"/>
            <a:ext cx="47550" cy="1168285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3294312" y="9466670"/>
            <a:ext cx="3783144" cy="4986946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926767" y="9479596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4828057" y="1001364"/>
            <a:ext cx="4248979" cy="7302634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4815358" y="1402080"/>
            <a:ext cx="4261678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8097282" y="9469968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1150630" y="15185714"/>
            <a:ext cx="101231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uOR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ET 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2423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https://gwips.ucc.ie/trash/hgt/hgt_gwips_3f81_fb343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623"/>
          <a:stretch/>
        </p:blipFill>
        <p:spPr bwMode="auto">
          <a:xfrm>
            <a:off x="1150628" y="955642"/>
            <a:ext cx="10393516" cy="7655816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Рисунок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629" y="9479280"/>
            <a:ext cx="10401283" cy="529108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/>
          <p:nvPr/>
        </p:nvCxnSpPr>
        <p:spPr>
          <a:xfrm flipH="1">
            <a:off x="5125746" y="8611458"/>
            <a:ext cx="1076934" cy="855211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/>
          <p:cNvCxnSpPr/>
          <p:nvPr/>
        </p:nvCxnSpPr>
        <p:spPr>
          <a:xfrm flipH="1">
            <a:off x="10613136" y="8611458"/>
            <a:ext cx="931008" cy="855211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5092632" y="9466670"/>
            <a:ext cx="5520504" cy="4956466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958690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783466" y="9490288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29" name="Прямоугольник 28"/>
          <p:cNvSpPr/>
          <p:nvPr/>
        </p:nvSpPr>
        <p:spPr>
          <a:xfrm>
            <a:off x="6237250" y="945483"/>
            <a:ext cx="5314662" cy="7665975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6237250" y="1337564"/>
            <a:ext cx="5306894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TextBox 41"/>
          <p:cNvSpPr txBox="1"/>
          <p:nvPr/>
        </p:nvSpPr>
        <p:spPr>
          <a:xfrm>
            <a:off x="6045594" y="9484846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sp>
        <p:nvSpPr>
          <p:cNvPr id="15" name="Прямоугольник 14"/>
          <p:cNvSpPr/>
          <p:nvPr/>
        </p:nvSpPr>
        <p:spPr>
          <a:xfrm>
            <a:off x="931574" y="15093682"/>
            <a:ext cx="108222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0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</a:rPr>
              <a:t>N-terminal extensions of the </a:t>
            </a:r>
            <a:r>
              <a:rPr lang="en-US" i="1" dirty="0">
                <a:solidFill>
                  <a:srgbClr val="000000"/>
                </a:solidFill>
                <a:latin typeface="Arial" panose="020B0604020202020204" pitchFamily="34" charset="0"/>
              </a:rPr>
              <a:t>MAPRE2 </a:t>
            </a:r>
            <a:r>
              <a:rPr lang="en-US" dirty="0" smtClean="0">
                <a:solidFill>
                  <a:srgbClr val="000000"/>
                </a:solidFill>
                <a:latin typeface="Arial" panose="020B0604020202020204" pitchFamily="34" charset="0"/>
              </a:rPr>
              <a:t>CDS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725634" y="11652515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</p:spTree>
    <p:extLst>
      <p:ext uri="{BB962C8B-B14F-4D97-AF65-F5344CB8AC3E}">
        <p14:creationId xmlns:p14="http://schemas.microsoft.com/office/powerpoint/2010/main" val="2313200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https://gwips.ucc.ie/trash/hgt/hgt_gwips_41ce_fb4bf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2718"/>
          <a:stretch/>
        </p:blipFill>
        <p:spPr bwMode="auto">
          <a:xfrm>
            <a:off x="1143010" y="953327"/>
            <a:ext cx="10407686" cy="7068817"/>
          </a:xfrm>
          <a:prstGeom prst="rect">
            <a:avLst/>
          </a:prstGeom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Рисунок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3010" y="9205457"/>
            <a:ext cx="10407687" cy="531360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Прямая соединительная линия 8"/>
          <p:cNvCxnSpPr>
            <a:endCxn id="27" idx="0"/>
          </p:cNvCxnSpPr>
          <p:nvPr/>
        </p:nvCxnSpPr>
        <p:spPr>
          <a:xfrm flipH="1">
            <a:off x="4703671" y="8022144"/>
            <a:ext cx="4480970" cy="1194566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Прямоугольник 10"/>
          <p:cNvSpPr/>
          <p:nvPr/>
        </p:nvSpPr>
        <p:spPr>
          <a:xfrm>
            <a:off x="4641528" y="9203784"/>
            <a:ext cx="5983800" cy="4954593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/>
          <p:cNvSpPr txBox="1"/>
          <p:nvPr/>
        </p:nvSpPr>
        <p:spPr>
          <a:xfrm>
            <a:off x="1150630" y="482678"/>
            <a:ext cx="2530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GWIPS-browser</a:t>
            </a:r>
            <a:endParaRPr lang="ru-RU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150630" y="8695804"/>
            <a:ext cx="2229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rips-browser</a:t>
            </a:r>
            <a:endParaRPr lang="ru-RU" sz="2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383711" y="9216710"/>
            <a:ext cx="639919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err="1" smtClean="0"/>
              <a:t>uTIS</a:t>
            </a:r>
            <a:endParaRPr lang="ru-RU" sz="20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5995951" y="9216710"/>
            <a:ext cx="979755" cy="4001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DS TIS</a:t>
            </a:r>
            <a:endParaRPr lang="ru-RU" sz="2000" b="1" dirty="0"/>
          </a:p>
        </p:txBody>
      </p:sp>
      <p:cxnSp>
        <p:nvCxnSpPr>
          <p:cNvPr id="17" name="Прямая соединительная линия 16"/>
          <p:cNvCxnSpPr/>
          <p:nvPr/>
        </p:nvCxnSpPr>
        <p:spPr>
          <a:xfrm flipH="1">
            <a:off x="10625328" y="8022144"/>
            <a:ext cx="925368" cy="118164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Прямоугольник 28"/>
          <p:cNvSpPr/>
          <p:nvPr/>
        </p:nvSpPr>
        <p:spPr>
          <a:xfrm>
            <a:off x="9184641" y="953327"/>
            <a:ext cx="2376000" cy="7068817"/>
          </a:xfrm>
          <a:prstGeom prst="rect">
            <a:avLst/>
          </a:prstGeom>
          <a:solidFill>
            <a:schemeClr val="accent1">
              <a:lumMod val="40000"/>
              <a:lumOff val="60000"/>
              <a:alpha val="31000"/>
            </a:schemeClr>
          </a:solidFill>
          <a:ln w="158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Стрелка вправо 25"/>
          <p:cNvSpPr/>
          <p:nvPr/>
        </p:nvSpPr>
        <p:spPr>
          <a:xfrm>
            <a:off x="9184641" y="1520667"/>
            <a:ext cx="2366055" cy="450850"/>
          </a:xfrm>
          <a:prstGeom prst="rightArrow">
            <a:avLst/>
          </a:prstGeom>
          <a:solidFill>
            <a:srgbClr val="FFC000">
              <a:alpha val="40000"/>
            </a:srgb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6" name="Прямоугольник 15"/>
          <p:cNvSpPr/>
          <p:nvPr/>
        </p:nvSpPr>
        <p:spPr>
          <a:xfrm>
            <a:off x="1143009" y="14844046"/>
            <a:ext cx="104176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not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</a:rPr>
              <a:t>N-terminal extensions of the </a:t>
            </a:r>
            <a:r>
              <a:rPr lang="en-US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ZIC2 </a:t>
            </a:r>
            <a:r>
              <a:rPr lang="en-US" dirty="0" smtClean="0">
                <a:solidFill>
                  <a:srgbClr val="000000"/>
                </a:solidFill>
                <a:latin typeface="Arial" panose="020B0604020202020204" pitchFamily="34" charset="0"/>
              </a:rPr>
              <a:t>CDS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using GWIPS- and Trips-browser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2942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3</TotalTime>
  <Words>373</Words>
  <Application>Microsoft Office PowerPoint</Application>
  <PresentationFormat>Произвольный</PresentationFormat>
  <Paragraphs>78</Paragraphs>
  <Slides>1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ександра</dc:creator>
  <cp:lastModifiedBy>Admin</cp:lastModifiedBy>
  <cp:revision>102</cp:revision>
  <dcterms:created xsi:type="dcterms:W3CDTF">2021-12-14T09:23:12Z</dcterms:created>
  <dcterms:modified xsi:type="dcterms:W3CDTF">2022-11-24T14:30:52Z</dcterms:modified>
</cp:coreProperties>
</file>